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1"/>
  </p:notesMasterIdLst>
  <p:sldIdLst>
    <p:sldId id="266" r:id="rId5"/>
    <p:sldId id="263" r:id="rId6"/>
    <p:sldId id="262" r:id="rId7"/>
    <p:sldId id="270" r:id="rId8"/>
    <p:sldId id="276" r:id="rId9"/>
    <p:sldId id="275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Zhou, Haihong" initials="ZH" lastIdx="2" clrIdx="0">
    <p:extLst>
      <p:ext uri="{19B8F6BF-5375-455C-9EA6-DF929625EA0E}">
        <p15:presenceInfo xmlns:p15="http://schemas.microsoft.com/office/powerpoint/2012/main" userId="S::Zhouhai@merck.com::359e7346-263f-4e71-a84c-549f28674e4a" providerId="AD"/>
      </p:ext>
    </p:extLst>
  </p:cmAuthor>
  <p:cmAuthor id="2" name="Noland, Cameron" initials="NC" lastIdx="1" clrIdx="1">
    <p:extLst>
      <p:ext uri="{19B8F6BF-5375-455C-9EA6-DF929625EA0E}">
        <p15:presenceInfo xmlns:p15="http://schemas.microsoft.com/office/powerpoint/2012/main" userId="S::nolandca@merck.com::de226cde-3043-4954-874c-9db897e318e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01D"/>
    <a:srgbClr val="009999"/>
    <a:srgbClr val="FFFFCC"/>
    <a:srgbClr val="FFCCFF"/>
    <a:srgbClr val="F8CBAD"/>
    <a:srgbClr val="33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90" d="100"/>
          <a:sy n="90" d="100"/>
        </p:scale>
        <p:origin x="2160" y="-54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F8E37B-DFD6-481B-AE75-DC5435849B5E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0A37F4-7CD5-427F-9392-0CA428D064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988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C0A37F4-7CD5-427F-9392-0CA428D06402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1120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02E53-18DC-49C7-A8D9-694F6102CB59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35CF-E2E3-4705-A19B-4C7A1A95B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332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02E53-18DC-49C7-A8D9-694F6102CB59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35CF-E2E3-4705-A19B-4C7A1A95B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953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02E53-18DC-49C7-A8D9-694F6102CB59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35CF-E2E3-4705-A19B-4C7A1A95B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7973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02E53-18DC-49C7-A8D9-694F6102CB59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35CF-E2E3-4705-A19B-4C7A1A95B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918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02E53-18DC-49C7-A8D9-694F6102CB59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35CF-E2E3-4705-A19B-4C7A1A95B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170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02E53-18DC-49C7-A8D9-694F6102CB59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35CF-E2E3-4705-A19B-4C7A1A95B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978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02E53-18DC-49C7-A8D9-694F6102CB59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35CF-E2E3-4705-A19B-4C7A1A95B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60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02E53-18DC-49C7-A8D9-694F6102CB59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35CF-E2E3-4705-A19B-4C7A1A95B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447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02E53-18DC-49C7-A8D9-694F6102CB59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35CF-E2E3-4705-A19B-4C7A1A95B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651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02E53-18DC-49C7-A8D9-694F6102CB59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35CF-E2E3-4705-A19B-4C7A1A95B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745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902E53-18DC-49C7-A8D9-694F6102CB59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0435CF-E2E3-4705-A19B-4C7A1A95B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0460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902E53-18DC-49C7-A8D9-694F6102CB59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0435CF-E2E3-4705-A19B-4C7A1A95B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827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7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Relationship Id="rId1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16F25EF-DEF9-44A3-9399-5113FC0FFBF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7326587"/>
              </p:ext>
            </p:extLst>
          </p:nvPr>
        </p:nvGraphicFramePr>
        <p:xfrm>
          <a:off x="1409907" y="5840137"/>
          <a:ext cx="3307866" cy="1733640"/>
        </p:xfrm>
        <a:graphic>
          <a:graphicData uri="http://schemas.openxmlformats.org/drawingml/2006/table">
            <a:tbl>
              <a:tblPr/>
              <a:tblGrid>
                <a:gridCol w="1114575">
                  <a:extLst>
                    <a:ext uri="{9D8B030D-6E8A-4147-A177-3AD203B41FA5}">
                      <a16:colId xmlns:a16="http://schemas.microsoft.com/office/drawing/2014/main" val="2921549722"/>
                    </a:ext>
                  </a:extLst>
                </a:gridCol>
                <a:gridCol w="731097">
                  <a:extLst>
                    <a:ext uri="{9D8B030D-6E8A-4147-A177-3AD203B41FA5}">
                      <a16:colId xmlns:a16="http://schemas.microsoft.com/office/drawing/2014/main" val="2715538324"/>
                    </a:ext>
                  </a:extLst>
                </a:gridCol>
                <a:gridCol w="731097">
                  <a:extLst>
                    <a:ext uri="{9D8B030D-6E8A-4147-A177-3AD203B41FA5}">
                      <a16:colId xmlns:a16="http://schemas.microsoft.com/office/drawing/2014/main" val="2966496521"/>
                    </a:ext>
                  </a:extLst>
                </a:gridCol>
                <a:gridCol w="731097">
                  <a:extLst>
                    <a:ext uri="{9D8B030D-6E8A-4147-A177-3AD203B41FA5}">
                      <a16:colId xmlns:a16="http://schemas.microsoft.com/office/drawing/2014/main" val="1714301116"/>
                    </a:ext>
                  </a:extLst>
                </a:gridCol>
              </a:tblGrid>
              <a:tr h="325373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body 2 flowed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body 1 bound to SARS-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V-2 Spike Extracellular domain</a:t>
                      </a:r>
                    </a:p>
                  </a:txBody>
                  <a:tcPr marL="6360" marR="6360" marT="636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8937252"/>
                  </a:ext>
                </a:extLst>
              </a:tr>
              <a:tr h="170820">
                <a:tc vMerge="1"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D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0197267"/>
                  </a:ext>
                </a:extLst>
              </a:tr>
              <a:tr h="1708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D11 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A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B8 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0154909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D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8900793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F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4229474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F3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4440489"/>
                  </a:ext>
                </a:extLst>
              </a:tr>
              <a:tr h="87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A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2240665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B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8434035"/>
                  </a:ext>
                </a:extLst>
              </a:tr>
              <a:tr h="1272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H7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0212990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535EBE5F-4092-4467-853F-352705B48324}"/>
              </a:ext>
            </a:extLst>
          </p:cNvPr>
          <p:cNvSpPr txBox="1"/>
          <p:nvPr/>
        </p:nvSpPr>
        <p:spPr>
          <a:xfrm>
            <a:off x="282638" y="665568"/>
            <a:ext cx="1266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/>
              <a:t>A. RBD binder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CF4F61D-947D-49C6-AD21-56879CA496D9}"/>
              </a:ext>
            </a:extLst>
          </p:cNvPr>
          <p:cNvSpPr txBox="1"/>
          <p:nvPr/>
        </p:nvSpPr>
        <p:spPr>
          <a:xfrm>
            <a:off x="282638" y="5341860"/>
            <a:ext cx="17958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/>
              <a:t>B. NTD and S2 binders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30E5CEF-E5CD-4782-C2FC-80004C2315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4067335"/>
              </p:ext>
            </p:extLst>
          </p:nvPr>
        </p:nvGraphicFramePr>
        <p:xfrm>
          <a:off x="471488" y="1261276"/>
          <a:ext cx="5915024" cy="3792653"/>
        </p:xfrm>
        <a:graphic>
          <a:graphicData uri="http://schemas.openxmlformats.org/drawingml/2006/table">
            <a:tbl>
              <a:tblPr/>
              <a:tblGrid>
                <a:gridCol w="739290">
                  <a:extLst>
                    <a:ext uri="{9D8B030D-6E8A-4147-A177-3AD203B41FA5}">
                      <a16:colId xmlns:a16="http://schemas.microsoft.com/office/drawing/2014/main" val="2921549722"/>
                    </a:ext>
                  </a:extLst>
                </a:gridCol>
                <a:gridCol w="419537">
                  <a:extLst>
                    <a:ext uri="{9D8B030D-6E8A-4147-A177-3AD203B41FA5}">
                      <a16:colId xmlns:a16="http://schemas.microsoft.com/office/drawing/2014/main" val="2979246866"/>
                    </a:ext>
                  </a:extLst>
                </a:gridCol>
                <a:gridCol w="419537">
                  <a:extLst>
                    <a:ext uri="{9D8B030D-6E8A-4147-A177-3AD203B41FA5}">
                      <a16:colId xmlns:a16="http://schemas.microsoft.com/office/drawing/2014/main" val="1496460406"/>
                    </a:ext>
                  </a:extLst>
                </a:gridCol>
                <a:gridCol w="419537">
                  <a:extLst>
                    <a:ext uri="{9D8B030D-6E8A-4147-A177-3AD203B41FA5}">
                      <a16:colId xmlns:a16="http://schemas.microsoft.com/office/drawing/2014/main" val="4252568160"/>
                    </a:ext>
                  </a:extLst>
                </a:gridCol>
                <a:gridCol w="424496">
                  <a:extLst>
                    <a:ext uri="{9D8B030D-6E8A-4147-A177-3AD203B41FA5}">
                      <a16:colId xmlns:a16="http://schemas.microsoft.com/office/drawing/2014/main" val="1452059582"/>
                    </a:ext>
                  </a:extLst>
                </a:gridCol>
                <a:gridCol w="477328">
                  <a:extLst>
                    <a:ext uri="{9D8B030D-6E8A-4147-A177-3AD203B41FA5}">
                      <a16:colId xmlns:a16="http://schemas.microsoft.com/office/drawing/2014/main" val="2799219605"/>
                    </a:ext>
                  </a:extLst>
                </a:gridCol>
                <a:gridCol w="454042">
                  <a:extLst>
                    <a:ext uri="{9D8B030D-6E8A-4147-A177-3AD203B41FA5}">
                      <a16:colId xmlns:a16="http://schemas.microsoft.com/office/drawing/2014/main" val="3799091704"/>
                    </a:ext>
                  </a:extLst>
                </a:gridCol>
                <a:gridCol w="582105">
                  <a:extLst>
                    <a:ext uri="{9D8B030D-6E8A-4147-A177-3AD203B41FA5}">
                      <a16:colId xmlns:a16="http://schemas.microsoft.com/office/drawing/2014/main" val="946718925"/>
                    </a:ext>
                  </a:extLst>
                </a:gridCol>
                <a:gridCol w="500609">
                  <a:extLst>
                    <a:ext uri="{9D8B030D-6E8A-4147-A177-3AD203B41FA5}">
                      <a16:colId xmlns:a16="http://schemas.microsoft.com/office/drawing/2014/main" val="1076556584"/>
                    </a:ext>
                  </a:extLst>
                </a:gridCol>
                <a:gridCol w="488967">
                  <a:extLst>
                    <a:ext uri="{9D8B030D-6E8A-4147-A177-3AD203B41FA5}">
                      <a16:colId xmlns:a16="http://schemas.microsoft.com/office/drawing/2014/main" val="809341488"/>
                    </a:ext>
                  </a:extLst>
                </a:gridCol>
                <a:gridCol w="488967">
                  <a:extLst>
                    <a:ext uri="{9D8B030D-6E8A-4147-A177-3AD203B41FA5}">
                      <a16:colId xmlns:a16="http://schemas.microsoft.com/office/drawing/2014/main" val="3068940920"/>
                    </a:ext>
                  </a:extLst>
                </a:gridCol>
                <a:gridCol w="500609">
                  <a:extLst>
                    <a:ext uri="{9D8B030D-6E8A-4147-A177-3AD203B41FA5}">
                      <a16:colId xmlns:a16="http://schemas.microsoft.com/office/drawing/2014/main" val="815574296"/>
                    </a:ext>
                  </a:extLst>
                </a:gridCol>
              </a:tblGrid>
              <a:tr h="325373">
                <a:tc rowSpan="3"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body 2 flowed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11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body 1 bound to SARS-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V-2 Spike Extracellular domain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body 1 bound to biotinylated SARS-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oV-2 Spike ECD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8937252"/>
                  </a:ext>
                </a:extLst>
              </a:tr>
              <a:tr h="170820">
                <a:tc vMerge="1">
                  <a:txBody>
                    <a:bodyPr/>
                    <a:lstStyle/>
                    <a:p>
                      <a:pPr algn="ctr" fontAlgn="ctr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D Class 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D Class 3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D Class 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BD Class ?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0197267"/>
                  </a:ext>
                </a:extLst>
              </a:tr>
              <a:tr h="17082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N 10933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N 10987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HH-7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E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B2 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F8 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C8 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H1 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H7 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A11 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A9 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0154909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HH-7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8094033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E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2135975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B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63469525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F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8574954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C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6984151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H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73019851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H7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42812285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A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889982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E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8462733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E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587857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D7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2915565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B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6623231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D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4779174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A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9160172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C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1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1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46748953"/>
                  </a:ext>
                </a:extLst>
              </a:tr>
              <a:tr h="13356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A9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</a:t>
                      </a:r>
                    </a:p>
                  </a:txBody>
                  <a:tcPr marL="6360" marR="6360" marT="636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CBA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8683390"/>
                  </a:ext>
                </a:extLst>
              </a:tr>
            </a:tbl>
          </a:graphicData>
        </a:graphic>
      </p:graphicFrame>
      <p:sp>
        <p:nvSpPr>
          <p:cNvPr id="3" name="Title 3">
            <a:extLst>
              <a:ext uri="{FF2B5EF4-FFF2-40B4-BE49-F238E27FC236}">
                <a16:creationId xmlns:a16="http://schemas.microsoft.com/office/drawing/2014/main" id="{A6787E76-9CD8-D057-2301-37F08AF76BAB}"/>
              </a:ext>
            </a:extLst>
          </p:cNvPr>
          <p:cNvSpPr txBox="1">
            <a:spLocks/>
          </p:cNvSpPr>
          <p:nvPr/>
        </p:nvSpPr>
        <p:spPr>
          <a:xfrm>
            <a:off x="282638" y="8006762"/>
            <a:ext cx="5915025" cy="47167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/>
              <a:t>Supplementary Figure 1. </a:t>
            </a:r>
            <a:r>
              <a:rPr lang="en-US" sz="1200" dirty="0"/>
              <a:t>Binning of candidate VHHs using Octet-HTX.</a:t>
            </a:r>
            <a:r>
              <a:rPr lang="en-US" sz="1200" spc="6" dirty="0"/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520365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2633AAEE-DB27-4144-9AC3-38F5CA672F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5485" y="1137651"/>
            <a:ext cx="5668566" cy="2603897"/>
          </a:xfrm>
          <a:prstGeom prst="rect">
            <a:avLst/>
          </a:prstGeom>
        </p:spPr>
      </p:pic>
      <p:sp>
        <p:nvSpPr>
          <p:cNvPr id="5" name="Title 3">
            <a:extLst>
              <a:ext uri="{FF2B5EF4-FFF2-40B4-BE49-F238E27FC236}">
                <a16:creationId xmlns:a16="http://schemas.microsoft.com/office/drawing/2014/main" id="{88B3294B-9B8B-49C5-9BA2-68C54D9CFE9F}"/>
              </a:ext>
            </a:extLst>
          </p:cNvPr>
          <p:cNvSpPr txBox="1">
            <a:spLocks/>
          </p:cNvSpPr>
          <p:nvPr/>
        </p:nvSpPr>
        <p:spPr>
          <a:xfrm>
            <a:off x="407490" y="4100330"/>
            <a:ext cx="5915025" cy="47167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/>
              <a:t>Supplementary Figure 2.</a:t>
            </a:r>
            <a:r>
              <a:rPr lang="en-US" sz="1200" dirty="0"/>
              <a:t> S</a:t>
            </a:r>
            <a:r>
              <a:rPr lang="en-US" sz="1200" spc="6" dirty="0"/>
              <a:t>equence coverage map obtained for spike protein S2 domain using HDX-MS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0618918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51F5AB31-4082-4D72-899B-CD774536E10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7109" y="721188"/>
            <a:ext cx="4018019" cy="32324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77C0A5C-15AB-42CB-A68F-40A15B864F6E}"/>
              </a:ext>
            </a:extLst>
          </p:cNvPr>
          <p:cNvSpPr txBox="1"/>
          <p:nvPr/>
        </p:nvSpPr>
        <p:spPr>
          <a:xfrm>
            <a:off x="441579" y="4116061"/>
            <a:ext cx="5724938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563"/>
              </a:spcAft>
            </a:pPr>
            <a:r>
              <a:rPr lang="en-US" sz="1100" b="1" dirty="0">
                <a:latin typeface="+mj-lt"/>
              </a:rPr>
              <a:t>Supplementary Figure 3</a:t>
            </a:r>
            <a:r>
              <a:rPr lang="en-US" sz="1100" dirty="0">
                <a:latin typeface="+mj-lt"/>
              </a:rPr>
              <a:t>. Differential heat map of time-course H/D exchange of recombinant CoV-2 RBD alone to that of Cov-2 RBD in complex with 7A9 VHH. </a:t>
            </a:r>
            <a:r>
              <a:rPr lang="en-US" sz="1100" dirty="0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CoV-2 RBD showed significant reduction in deuterium uptake upon binding to the </a:t>
            </a:r>
            <a:r>
              <a:rPr lang="en-US" sz="110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rPr>
              <a:t>7A9 VHH at sequences AA353-364, NRKRISNCVADY,</a:t>
            </a:r>
            <a:r>
              <a:rPr lang="en-US" sz="1100" dirty="0">
                <a:solidFill>
                  <a:srgbClr val="000000"/>
                </a:solidFill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 which should be assigned as the main binding site on CoV-2 RBD. Moreover, there was significant reduction in deuterium </a:t>
            </a:r>
            <a:r>
              <a:rPr lang="en-US" sz="1100" dirty="0">
                <a:latin typeface="+mj-lt"/>
                <a:ea typeface="Calibri" panose="020F0502020204030204" pitchFamily="34" charset="0"/>
                <a:cs typeface="Calibri" panose="020F0502020204030204" pitchFamily="34" charset="0"/>
              </a:rPr>
              <a:t>sequences AA391-395, FTNVY, AA461-465, KPFER, AA521-527, ATVCGPK, and minor but detectable reduction at AA575-583, VRDPQTL.</a:t>
            </a:r>
            <a:endParaRPr lang="en-US" sz="1100" dirty="0"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93784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77C0A5C-15AB-42CB-A68F-40A15B864F6E}"/>
              </a:ext>
            </a:extLst>
          </p:cNvPr>
          <p:cNvSpPr txBox="1"/>
          <p:nvPr/>
        </p:nvSpPr>
        <p:spPr>
          <a:xfrm>
            <a:off x="327764" y="3971835"/>
            <a:ext cx="6188650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563"/>
              </a:spcAft>
            </a:pPr>
            <a:r>
              <a:rPr lang="en-US" sz="1100" b="1" dirty="0">
                <a:latin typeface="+mj-lt"/>
              </a:rPr>
              <a:t>Supplementary Figure 4</a:t>
            </a:r>
            <a:r>
              <a:rPr lang="en-US" sz="1100" dirty="0">
                <a:latin typeface="+mj-lt"/>
              </a:rPr>
              <a:t>. </a:t>
            </a:r>
            <a:r>
              <a:rPr lang="en-US" sz="1100" b="1" dirty="0">
                <a:latin typeface="+mj-lt"/>
              </a:rPr>
              <a:t>A.</a:t>
            </a:r>
            <a:r>
              <a:rPr lang="en-US" sz="1100" b="1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+mj-lt"/>
              </a:rPr>
              <a:t>Overlay of the crystal structure of VHH 7A9 (dark grey) bound to the RBD (light grey) with the structure of the Spike protein in the closed state (PDB: 7DF3) showing that the VHH would clash with the NTD of the neighboring protomer (cyan). </a:t>
            </a:r>
            <a:r>
              <a:rPr lang="en-US" sz="1100" b="1" dirty="0">
                <a:latin typeface="+mj-lt"/>
              </a:rPr>
              <a:t>B. </a:t>
            </a:r>
            <a:r>
              <a:rPr lang="en-US" sz="1100" dirty="0">
                <a:latin typeface="+mj-lt"/>
              </a:rPr>
              <a:t>Overlay of the crystal structure of VHH 7A9 (dark grey) bound to the RBD (light grey) with the structure of the Spike protein in the open state (PDB: 6XKL) showing that the VHH would clash with the NTD of the neighboring protomer (cyan). </a:t>
            </a:r>
            <a:endParaRPr lang="en-US" sz="1100" dirty="0"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22AC9D5-EB34-4D9D-82C2-D9A1BFA8D43A}"/>
              </a:ext>
            </a:extLst>
          </p:cNvPr>
          <p:cNvSpPr txBox="1"/>
          <p:nvPr/>
        </p:nvSpPr>
        <p:spPr>
          <a:xfrm>
            <a:off x="38902" y="567026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0791F54-F2DF-4212-B0CE-73EB5765183D}"/>
              </a:ext>
            </a:extLst>
          </p:cNvPr>
          <p:cNvSpPr txBox="1"/>
          <p:nvPr/>
        </p:nvSpPr>
        <p:spPr>
          <a:xfrm>
            <a:off x="2996205" y="567026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pic>
        <p:nvPicPr>
          <p:cNvPr id="11" name="Picture 10" descr="A close-up of a crystal&#10;&#10;Description automatically generated with low confidence">
            <a:extLst>
              <a:ext uri="{FF2B5EF4-FFF2-40B4-BE49-F238E27FC236}">
                <a16:creationId xmlns:a16="http://schemas.microsoft.com/office/drawing/2014/main" id="{67A85481-41D4-4F8C-8C5F-BF129C7B0A0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52" r="9996"/>
          <a:stretch/>
        </p:blipFill>
        <p:spPr>
          <a:xfrm>
            <a:off x="3429000" y="725545"/>
            <a:ext cx="3147090" cy="3024044"/>
          </a:xfrm>
          <a:prstGeom prst="rect">
            <a:avLst/>
          </a:prstGeom>
        </p:spPr>
      </p:pic>
      <p:pic>
        <p:nvPicPr>
          <p:cNvPr id="13" name="Picture 12" descr="A picture containing necklet&#10;&#10;Description automatically generated">
            <a:extLst>
              <a:ext uri="{FF2B5EF4-FFF2-40B4-BE49-F238E27FC236}">
                <a16:creationId xmlns:a16="http://schemas.microsoft.com/office/drawing/2014/main" id="{99F742D5-2FB4-4CAA-ADFF-EDCEB16209D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90" r="7493"/>
          <a:stretch/>
        </p:blipFill>
        <p:spPr>
          <a:xfrm>
            <a:off x="236320" y="725545"/>
            <a:ext cx="2851329" cy="30240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0294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AC3C12D5-49A7-4268-9CD2-926B0C8BDDB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910"/>
          <a:stretch/>
        </p:blipFill>
        <p:spPr>
          <a:xfrm>
            <a:off x="327693" y="1037345"/>
            <a:ext cx="1598384" cy="354487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5C1CE5D-08BA-4AE8-B9F2-D5DFCCAC23E6}"/>
              </a:ext>
            </a:extLst>
          </p:cNvPr>
          <p:cNvSpPr txBox="1"/>
          <p:nvPr/>
        </p:nvSpPr>
        <p:spPr>
          <a:xfrm>
            <a:off x="71077" y="4975593"/>
            <a:ext cx="6715846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+mj-lt"/>
              </a:rPr>
              <a:t>Supplementary Figure 5</a:t>
            </a:r>
            <a:r>
              <a:rPr lang="en-US" sz="1100" dirty="0">
                <a:latin typeface="+mj-lt"/>
              </a:rPr>
              <a:t>. </a:t>
            </a:r>
            <a:r>
              <a:rPr lang="en-US" sz="1100" b="1" dirty="0">
                <a:latin typeface="+mj-lt"/>
              </a:rPr>
              <a:t>A. </a:t>
            </a:r>
            <a:r>
              <a:rPr lang="en-US" sz="1100" dirty="0">
                <a:latin typeface="+mj-lt"/>
              </a:rPr>
              <a:t>A</a:t>
            </a:r>
            <a:r>
              <a:rPr lang="en-US" sz="1100" baseline="30000" dirty="0">
                <a:latin typeface="+mj-lt"/>
              </a:rPr>
              <a:t>280</a:t>
            </a:r>
            <a:r>
              <a:rPr lang="en-US" sz="1100" dirty="0">
                <a:latin typeface="+mj-lt"/>
              </a:rPr>
              <a:t> absorbance scans from AUC experiments showing scans #1-50 for each sample. Comparison of top and middle panels shows a dramatic change in sedimentation rate of the spike upon binding to 7A9 VHH, indicating a disruption of the spike trimer upon binding. Comparison of top and bottom panels shows a less pronounced change in sedimentation rate of the spike upon binding to 1E4, indicating binding to the trimer without disruption. </a:t>
            </a:r>
            <a:r>
              <a:rPr lang="en-US" sz="1100" b="1" dirty="0">
                <a:latin typeface="+mj-lt"/>
              </a:rPr>
              <a:t>B.</a:t>
            </a:r>
            <a:r>
              <a:rPr lang="en-US" sz="1100" dirty="0">
                <a:latin typeface="+mj-lt"/>
              </a:rPr>
              <a:t> SEC-MALS UV (280nm) and molecular weight as a function of elution time. Comparison of the SARS-CoV2 Spike (blue) to SARS-CoV2 Spike + 7A9 (teal) samples shows a dramatic decrease in molecular weight upon 7A9 binding, whereas 1E4 binding (purple) leads to a slight increase in molecular weight. </a:t>
            </a:r>
            <a:r>
              <a:rPr lang="en-US" sz="1100" b="1" dirty="0">
                <a:latin typeface="+mj-lt"/>
              </a:rPr>
              <a:t>C.</a:t>
            </a:r>
            <a:r>
              <a:rPr lang="en-US" sz="1100" dirty="0">
                <a:latin typeface="+mj-lt"/>
              </a:rPr>
              <a:t> Comparison of calculated molecular weights from AUC and SEC-MALS experiments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5A1B344-87F4-A30B-040E-36BF0DF68A4A}"/>
              </a:ext>
            </a:extLst>
          </p:cNvPr>
          <p:cNvSpPr txBox="1"/>
          <p:nvPr/>
        </p:nvSpPr>
        <p:spPr>
          <a:xfrm>
            <a:off x="132870" y="92880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/>
              <a:t>A</a:t>
            </a:r>
          </a:p>
        </p:txBody>
      </p:sp>
      <p:pic>
        <p:nvPicPr>
          <p:cNvPr id="4" name="Picture 3" descr="A diagram of a graph&#10;&#10;Description automatically generated">
            <a:extLst>
              <a:ext uri="{FF2B5EF4-FFF2-40B4-BE49-F238E27FC236}">
                <a16:creationId xmlns:a16="http://schemas.microsoft.com/office/drawing/2014/main" id="{3AF7F43D-4161-1E46-E83A-78240452C52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2269" y="1037346"/>
            <a:ext cx="4646827" cy="197046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4F0324C-0542-AA8F-E5BD-5B1680FA34F9}"/>
              </a:ext>
            </a:extLst>
          </p:cNvPr>
          <p:cNvSpPr txBox="1"/>
          <p:nvPr/>
        </p:nvSpPr>
        <p:spPr>
          <a:xfrm>
            <a:off x="2042892" y="92880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E39B289-8C1F-11C5-6BB7-0A96E8051840}"/>
              </a:ext>
            </a:extLst>
          </p:cNvPr>
          <p:cNvSpPr txBox="1"/>
          <p:nvPr/>
        </p:nvSpPr>
        <p:spPr>
          <a:xfrm>
            <a:off x="2042892" y="3083082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/>
              <a:t>C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D672ADED-26AC-F525-A9E2-D1B035D1D18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16386" y="3327628"/>
            <a:ext cx="4347342" cy="10068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93717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plant&#10;&#10;Description automatically generated with low confidence">
            <a:extLst>
              <a:ext uri="{FF2B5EF4-FFF2-40B4-BE49-F238E27FC236}">
                <a16:creationId xmlns:a16="http://schemas.microsoft.com/office/drawing/2014/main" id="{EE972FA8-2163-4A94-88DC-7F15B34693B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924" y="286571"/>
            <a:ext cx="2036851" cy="2036851"/>
          </a:xfrm>
          <a:prstGeom prst="rect">
            <a:avLst/>
          </a:prstGeom>
        </p:spPr>
      </p:pic>
      <p:pic>
        <p:nvPicPr>
          <p:cNvPr id="7" name="Picture 6" descr="A close-up of a diamond&#10;&#10;Description automatically generated with low confidence">
            <a:extLst>
              <a:ext uri="{FF2B5EF4-FFF2-40B4-BE49-F238E27FC236}">
                <a16:creationId xmlns:a16="http://schemas.microsoft.com/office/drawing/2014/main" id="{AF719F42-0052-4BC4-B2C8-03CD011D930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6923" y="286570"/>
            <a:ext cx="2069057" cy="206905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1EF3A62-FA1D-4F14-8DAB-ECC58D5EE57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2924" y="286571"/>
            <a:ext cx="2036851" cy="2036851"/>
          </a:xfrm>
          <a:prstGeom prst="rect">
            <a:avLst/>
          </a:prstGeom>
        </p:spPr>
      </p:pic>
      <p:pic>
        <p:nvPicPr>
          <p:cNvPr id="13" name="Picture 12" descr="A close up of a flower&#10;&#10;Description automatically generated with low confidence">
            <a:extLst>
              <a:ext uri="{FF2B5EF4-FFF2-40B4-BE49-F238E27FC236}">
                <a16:creationId xmlns:a16="http://schemas.microsoft.com/office/drawing/2014/main" id="{65EC26C9-BECC-4400-815B-D949C51FA06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4690" y="1865054"/>
            <a:ext cx="2214642" cy="221464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F8302F3-05DD-4DD5-BFCF-97350251883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158" y="1864209"/>
            <a:ext cx="2218919" cy="2218919"/>
          </a:xfrm>
          <a:prstGeom prst="rect">
            <a:avLst/>
          </a:prstGeom>
        </p:spPr>
      </p:pic>
      <p:pic>
        <p:nvPicPr>
          <p:cNvPr id="17" name="Picture 16" descr="A picture containing chessman, accessory, necklet&#10;&#10;Description automatically generated">
            <a:extLst>
              <a:ext uri="{FF2B5EF4-FFF2-40B4-BE49-F238E27FC236}">
                <a16:creationId xmlns:a16="http://schemas.microsoft.com/office/drawing/2014/main" id="{6DC175C2-0015-4A1C-BFF5-B208DA6B049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1269" y="1865054"/>
            <a:ext cx="2218074" cy="2218074"/>
          </a:xfrm>
          <a:prstGeom prst="rect">
            <a:avLst/>
          </a:prstGeom>
        </p:spPr>
      </p:pic>
      <p:pic>
        <p:nvPicPr>
          <p:cNvPr id="19" name="Picture 18" descr="A close-up of a crystal&#10;&#10;Description automatically generated with low confidence">
            <a:extLst>
              <a:ext uri="{FF2B5EF4-FFF2-40B4-BE49-F238E27FC236}">
                <a16:creationId xmlns:a16="http://schemas.microsoft.com/office/drawing/2014/main" id="{91580E35-3842-4D00-8418-FE5DBD77A5B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1658" y="3748712"/>
            <a:ext cx="2214642" cy="2214642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256101C3-5169-44DE-A6B8-B54BC411FE86}"/>
              </a:ext>
            </a:extLst>
          </p:cNvPr>
          <p:cNvGrpSpPr/>
          <p:nvPr/>
        </p:nvGrpSpPr>
        <p:grpSpPr>
          <a:xfrm>
            <a:off x="2585967" y="6059414"/>
            <a:ext cx="1655553" cy="1444841"/>
            <a:chOff x="2585967" y="6312300"/>
            <a:chExt cx="1655553" cy="1444841"/>
          </a:xfrm>
        </p:grpSpPr>
        <p:pic>
          <p:nvPicPr>
            <p:cNvPr id="3" name="Picture 2" descr="A picture containing light&#10;&#10;Description automatically generated">
              <a:extLst>
                <a:ext uri="{FF2B5EF4-FFF2-40B4-BE49-F238E27FC236}">
                  <a16:creationId xmlns:a16="http://schemas.microsoft.com/office/drawing/2014/main" id="{1011E9CB-494C-48F1-A757-0922100CC6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274" t="15694" r="20255" b="11673"/>
            <a:stretch/>
          </p:blipFill>
          <p:spPr>
            <a:xfrm>
              <a:off x="2793646" y="6312300"/>
              <a:ext cx="1292369" cy="1433745"/>
            </a:xfrm>
            <a:prstGeom prst="rect">
              <a:avLst/>
            </a:prstGeom>
          </p:spPr>
        </p:pic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96D53C5A-6295-4D83-8FA6-F9EF32122878}"/>
                </a:ext>
              </a:extLst>
            </p:cNvPr>
            <p:cNvSpPr txBox="1"/>
            <p:nvPr/>
          </p:nvSpPr>
          <p:spPr>
            <a:xfrm>
              <a:off x="2585967" y="6794613"/>
              <a:ext cx="412292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355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F394DF5-578E-4593-854D-5665E2B40D32}"/>
                </a:ext>
              </a:extLst>
            </p:cNvPr>
            <p:cNvSpPr txBox="1"/>
            <p:nvPr/>
          </p:nvSpPr>
          <p:spPr>
            <a:xfrm>
              <a:off x="2837965" y="7236134"/>
              <a:ext cx="412292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357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354023C7-7023-4566-A82D-5B7E74CABDE7}"/>
                </a:ext>
              </a:extLst>
            </p:cNvPr>
            <p:cNvSpPr txBox="1"/>
            <p:nvPr/>
          </p:nvSpPr>
          <p:spPr>
            <a:xfrm>
              <a:off x="3834036" y="7457121"/>
              <a:ext cx="40748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rgbClr val="007A7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119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FF996D85-FEC9-4B32-A127-4B7B1EF81109}"/>
                </a:ext>
              </a:extLst>
            </p:cNvPr>
            <p:cNvSpPr txBox="1"/>
            <p:nvPr/>
          </p:nvSpPr>
          <p:spPr>
            <a:xfrm>
              <a:off x="3807941" y="6968911"/>
              <a:ext cx="40748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rgbClr val="007A7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104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F8287824-B05B-4479-8D17-10DD2A481D06}"/>
                </a:ext>
              </a:extLst>
            </p:cNvPr>
            <p:cNvSpPr txBox="1"/>
            <p:nvPr/>
          </p:nvSpPr>
          <p:spPr>
            <a:xfrm>
              <a:off x="3557756" y="6631514"/>
              <a:ext cx="40267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rgbClr val="007A7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06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16575A0D-846B-47CF-A5F0-ABFF2214BD63}"/>
                </a:ext>
              </a:extLst>
            </p:cNvPr>
            <p:cNvSpPr txBox="1"/>
            <p:nvPr/>
          </p:nvSpPr>
          <p:spPr>
            <a:xfrm>
              <a:off x="2858691" y="6327015"/>
              <a:ext cx="40748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rgbClr val="007A7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110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3C108ED6-2439-43B9-B59B-977236B4BAB3}"/>
                </a:ext>
              </a:extLst>
            </p:cNvPr>
            <p:cNvSpPr txBox="1"/>
            <p:nvPr/>
          </p:nvSpPr>
          <p:spPr>
            <a:xfrm>
              <a:off x="3153840" y="6994229"/>
              <a:ext cx="396262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rgbClr val="007A7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07</a:t>
              </a:r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A9C607A7-3FF6-4AC9-8C8B-CB24C33FA908}"/>
                </a:ext>
              </a:extLst>
            </p:cNvPr>
            <p:cNvSpPr/>
            <p:nvPr/>
          </p:nvSpPr>
          <p:spPr>
            <a:xfrm>
              <a:off x="2656251" y="6326367"/>
              <a:ext cx="1569880" cy="1430774"/>
            </a:xfrm>
            <a:prstGeom prst="rect">
              <a:avLst/>
            </a:prstGeom>
            <a:noFill/>
            <a:ln w="19050">
              <a:solidFill>
                <a:srgbClr val="007A73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0DDE57F8-7705-4DD0-BB42-3E34B5AD49C0}"/>
              </a:ext>
            </a:extLst>
          </p:cNvPr>
          <p:cNvGrpSpPr/>
          <p:nvPr/>
        </p:nvGrpSpPr>
        <p:grpSpPr>
          <a:xfrm>
            <a:off x="771402" y="6059414"/>
            <a:ext cx="1597657" cy="1451234"/>
            <a:chOff x="771402" y="6312300"/>
            <a:chExt cx="1597657" cy="1451234"/>
          </a:xfrm>
        </p:grpSpPr>
        <p:pic>
          <p:nvPicPr>
            <p:cNvPr id="6" name="Picture 5" descr="A picture containing light&#10;&#10;Description automatically generated">
              <a:extLst>
                <a:ext uri="{FF2B5EF4-FFF2-40B4-BE49-F238E27FC236}">
                  <a16:creationId xmlns:a16="http://schemas.microsoft.com/office/drawing/2014/main" id="{CF59083F-8FF2-419D-82A4-238D51CD1E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27" t="15091" r="16790" b="9154"/>
            <a:stretch/>
          </p:blipFill>
          <p:spPr>
            <a:xfrm>
              <a:off x="868624" y="6312300"/>
              <a:ext cx="1432596" cy="1451234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4D45FBC0-DECF-452C-9783-188A7594E1AE}"/>
                </a:ext>
              </a:extLst>
            </p:cNvPr>
            <p:cNvSpPr txBox="1"/>
            <p:nvPr/>
          </p:nvSpPr>
          <p:spPr>
            <a:xfrm>
              <a:off x="771402" y="6488504"/>
              <a:ext cx="412292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355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8BAE846B-F7B0-4645-8889-B2E1D4DAC308}"/>
                </a:ext>
              </a:extLst>
            </p:cNvPr>
            <p:cNvSpPr txBox="1"/>
            <p:nvPr/>
          </p:nvSpPr>
          <p:spPr>
            <a:xfrm>
              <a:off x="951654" y="7188272"/>
              <a:ext cx="412292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357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D046AD10-A1CC-465F-B5C7-31F9CD35C532}"/>
                </a:ext>
              </a:extLst>
            </p:cNvPr>
            <p:cNvSpPr txBox="1"/>
            <p:nvPr/>
          </p:nvSpPr>
          <p:spPr>
            <a:xfrm>
              <a:off x="1513826" y="7461810"/>
              <a:ext cx="35458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rgbClr val="69E17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59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7A8F16DF-9932-4205-BBC3-721FA35F0C9A}"/>
                </a:ext>
              </a:extLst>
            </p:cNvPr>
            <p:cNvSpPr txBox="1"/>
            <p:nvPr/>
          </p:nvSpPr>
          <p:spPr>
            <a:xfrm>
              <a:off x="1835541" y="6777368"/>
              <a:ext cx="35939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rgbClr val="69E17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99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313C30A1-1799-489F-8749-2DC72767FECF}"/>
                </a:ext>
              </a:extLst>
            </p:cNvPr>
            <p:cNvSpPr txBox="1"/>
            <p:nvPr/>
          </p:nvSpPr>
          <p:spPr>
            <a:xfrm>
              <a:off x="1352899" y="6396080"/>
              <a:ext cx="35458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rgbClr val="69E17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96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05F2EC2E-2B01-4123-AF02-BBA54E8870EF}"/>
                </a:ext>
              </a:extLst>
            </p:cNvPr>
            <p:cNvSpPr txBox="1"/>
            <p:nvPr/>
          </p:nvSpPr>
          <p:spPr>
            <a:xfrm>
              <a:off x="1324014" y="6882245"/>
              <a:ext cx="35939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rgbClr val="69E17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98</a:t>
              </a:r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CA8401F0-4A05-45FA-834B-DB3D3851D8B1}"/>
                </a:ext>
              </a:extLst>
            </p:cNvPr>
            <p:cNvSpPr/>
            <p:nvPr/>
          </p:nvSpPr>
          <p:spPr>
            <a:xfrm>
              <a:off x="799179" y="6328175"/>
              <a:ext cx="1569880" cy="1430774"/>
            </a:xfrm>
            <a:prstGeom prst="rect">
              <a:avLst/>
            </a:prstGeom>
            <a:noFill/>
            <a:ln w="19050">
              <a:solidFill>
                <a:srgbClr val="AFEFB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8070662D-1257-42F3-9D6F-06DB0361ADD4}"/>
              </a:ext>
            </a:extLst>
          </p:cNvPr>
          <p:cNvGrpSpPr/>
          <p:nvPr/>
        </p:nvGrpSpPr>
        <p:grpSpPr>
          <a:xfrm>
            <a:off x="4516372" y="6073481"/>
            <a:ext cx="1672868" cy="1430774"/>
            <a:chOff x="4516372" y="6326367"/>
            <a:chExt cx="1672868" cy="1430774"/>
          </a:xfrm>
        </p:grpSpPr>
        <p:pic>
          <p:nvPicPr>
            <p:cNvPr id="9" name="Picture 8" descr="A picture containing purple, colorful&#10;&#10;Description automatically generated">
              <a:extLst>
                <a:ext uri="{FF2B5EF4-FFF2-40B4-BE49-F238E27FC236}">
                  <a16:creationId xmlns:a16="http://schemas.microsoft.com/office/drawing/2014/main" id="{3B81A3D4-EC41-4C21-8490-42D0C293EF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76" t="12742" r="5854" b="15659"/>
            <a:stretch/>
          </p:blipFill>
          <p:spPr>
            <a:xfrm>
              <a:off x="4516372" y="6379464"/>
              <a:ext cx="1629954" cy="1352782"/>
            </a:xfrm>
            <a:prstGeom prst="rect">
              <a:avLst/>
            </a:prstGeom>
          </p:spPr>
        </p:pic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5409C732-240A-479B-AC76-75461EFB98D8}"/>
                </a:ext>
              </a:extLst>
            </p:cNvPr>
            <p:cNvSpPr txBox="1"/>
            <p:nvPr/>
          </p:nvSpPr>
          <p:spPr>
            <a:xfrm>
              <a:off x="4591721" y="6496160"/>
              <a:ext cx="412292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355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A25F0A34-45F2-4032-A63C-4D101637FA68}"/>
                </a:ext>
              </a:extLst>
            </p:cNvPr>
            <p:cNvSpPr txBox="1"/>
            <p:nvPr/>
          </p:nvSpPr>
          <p:spPr>
            <a:xfrm>
              <a:off x="4725375" y="7330295"/>
              <a:ext cx="412292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357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05AA986F-8485-4578-8317-E0D19512CFA0}"/>
                </a:ext>
              </a:extLst>
            </p:cNvPr>
            <p:cNvSpPr txBox="1"/>
            <p:nvPr/>
          </p:nvSpPr>
          <p:spPr>
            <a:xfrm>
              <a:off x="5328056" y="6425973"/>
              <a:ext cx="396262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rgbClr val="C9C4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92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37975148-FA7C-44EA-A49A-92AEF555A5E1}"/>
                </a:ext>
              </a:extLst>
            </p:cNvPr>
            <p:cNvSpPr txBox="1"/>
            <p:nvPr/>
          </p:nvSpPr>
          <p:spPr>
            <a:xfrm>
              <a:off x="5564183" y="6878602"/>
              <a:ext cx="41870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rgbClr val="C9C4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194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7180A9D3-AEEB-43D2-98BC-4CC880A07272}"/>
                </a:ext>
              </a:extLst>
            </p:cNvPr>
            <p:cNvSpPr txBox="1"/>
            <p:nvPr/>
          </p:nvSpPr>
          <p:spPr>
            <a:xfrm>
              <a:off x="5265252" y="7208452"/>
              <a:ext cx="40748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rgbClr val="C9C4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195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7165B218-B435-4B3C-8F66-81658BBD25E4}"/>
                </a:ext>
              </a:extLst>
            </p:cNvPr>
            <p:cNvSpPr txBox="1"/>
            <p:nvPr/>
          </p:nvSpPr>
          <p:spPr>
            <a:xfrm>
              <a:off x="5786566" y="7237390"/>
              <a:ext cx="40267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50" dirty="0">
                  <a:solidFill>
                    <a:srgbClr val="C9C4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96</a:t>
              </a:r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858CA764-DB88-454E-8EEE-E70C4E43EDDE}"/>
                </a:ext>
              </a:extLst>
            </p:cNvPr>
            <p:cNvSpPr/>
            <p:nvPr/>
          </p:nvSpPr>
          <p:spPr>
            <a:xfrm>
              <a:off x="4539751" y="6326367"/>
              <a:ext cx="1569880" cy="1430774"/>
            </a:xfrm>
            <a:prstGeom prst="rect">
              <a:avLst/>
            </a:prstGeom>
            <a:noFill/>
            <a:ln w="19050">
              <a:solidFill>
                <a:srgbClr val="FFFF99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</p:grpSp>
      <p:sp>
        <p:nvSpPr>
          <p:cNvPr id="87" name="TextBox 86">
            <a:extLst>
              <a:ext uri="{FF2B5EF4-FFF2-40B4-BE49-F238E27FC236}">
                <a16:creationId xmlns:a16="http://schemas.microsoft.com/office/drawing/2014/main" id="{EABD7378-F778-4A39-87BA-6ABC902B19C7}"/>
              </a:ext>
            </a:extLst>
          </p:cNvPr>
          <p:cNvSpPr txBox="1"/>
          <p:nvPr/>
        </p:nvSpPr>
        <p:spPr>
          <a:xfrm>
            <a:off x="725854" y="286570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3974ADBE-A0B5-4B9B-BC19-623B84D73643}"/>
              </a:ext>
            </a:extLst>
          </p:cNvPr>
          <p:cNvSpPr txBox="1"/>
          <p:nvPr/>
        </p:nvSpPr>
        <p:spPr>
          <a:xfrm>
            <a:off x="725854" y="2030112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F9380427-5136-4360-91B2-5CB58CF2CC2A}"/>
              </a:ext>
            </a:extLst>
          </p:cNvPr>
          <p:cNvSpPr txBox="1"/>
          <p:nvPr/>
        </p:nvSpPr>
        <p:spPr>
          <a:xfrm>
            <a:off x="725854" y="3925806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3B494692-121E-4057-BE10-B2A1A6650DC5}"/>
              </a:ext>
            </a:extLst>
          </p:cNvPr>
          <p:cNvSpPr txBox="1"/>
          <p:nvPr/>
        </p:nvSpPr>
        <p:spPr>
          <a:xfrm>
            <a:off x="725854" y="5748669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92" name="Picture 91" descr="A picture containing plant, decorated&#10;&#10;Description automatically generated">
            <a:extLst>
              <a:ext uri="{FF2B5EF4-FFF2-40B4-BE49-F238E27FC236}">
                <a16:creationId xmlns:a16="http://schemas.microsoft.com/office/drawing/2014/main" id="{D4E62B10-1971-4BE5-8165-C72EDFDB8D0B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8543" y="3746996"/>
            <a:ext cx="2218075" cy="2218075"/>
          </a:xfrm>
          <a:prstGeom prst="rect">
            <a:avLst/>
          </a:prstGeom>
        </p:spPr>
      </p:pic>
      <p:pic>
        <p:nvPicPr>
          <p:cNvPr id="94" name="Picture 93" descr="A close-up of a crystal&#10;&#10;Description automatically generated with low confidence">
            <a:extLst>
              <a:ext uri="{FF2B5EF4-FFF2-40B4-BE49-F238E27FC236}">
                <a16:creationId xmlns:a16="http://schemas.microsoft.com/office/drawing/2014/main" id="{8A202CD9-7AEF-4E1A-98CC-5F5A038D580F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584" y="3882501"/>
            <a:ext cx="2218919" cy="2218919"/>
          </a:xfrm>
          <a:prstGeom prst="rect">
            <a:avLst/>
          </a:prstGeom>
        </p:spPr>
      </p:pic>
      <p:grpSp>
        <p:nvGrpSpPr>
          <p:cNvPr id="97" name="Group 96">
            <a:extLst>
              <a:ext uri="{FF2B5EF4-FFF2-40B4-BE49-F238E27FC236}">
                <a16:creationId xmlns:a16="http://schemas.microsoft.com/office/drawing/2014/main" id="{BD4DC202-3829-42ED-AD26-269BA18CCA37}"/>
              </a:ext>
            </a:extLst>
          </p:cNvPr>
          <p:cNvGrpSpPr/>
          <p:nvPr/>
        </p:nvGrpSpPr>
        <p:grpSpPr>
          <a:xfrm>
            <a:off x="4197689" y="4204723"/>
            <a:ext cx="2000254" cy="1321015"/>
            <a:chOff x="4157598" y="6355941"/>
            <a:chExt cx="3305809" cy="2183236"/>
          </a:xfrm>
        </p:grpSpPr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D822DD9A-D3E2-43AB-B06D-F0DE007FF3AC}"/>
                </a:ext>
              </a:extLst>
            </p:cNvPr>
            <p:cNvGrpSpPr/>
            <p:nvPr/>
          </p:nvGrpSpPr>
          <p:grpSpPr>
            <a:xfrm>
              <a:off x="4157598" y="6355941"/>
              <a:ext cx="3305809" cy="2183236"/>
              <a:chOff x="2446765" y="4277542"/>
              <a:chExt cx="1983714" cy="1310092"/>
            </a:xfrm>
          </p:grpSpPr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D8D3AC50-622B-4962-862A-EB8648E4CA6A}"/>
                  </a:ext>
                </a:extLst>
              </p:cNvPr>
              <p:cNvGrpSpPr/>
              <p:nvPr/>
            </p:nvGrpSpPr>
            <p:grpSpPr>
              <a:xfrm>
                <a:off x="2846838" y="4277542"/>
                <a:ext cx="1162186" cy="1127896"/>
                <a:chOff x="8604069" y="2110741"/>
                <a:chExt cx="2066108" cy="2005149"/>
              </a:xfrm>
            </p:grpSpPr>
            <p:sp>
              <p:nvSpPr>
                <p:cNvPr id="39" name="Freeform: Shape 38">
                  <a:extLst>
                    <a:ext uri="{FF2B5EF4-FFF2-40B4-BE49-F238E27FC236}">
                      <a16:creationId xmlns:a16="http://schemas.microsoft.com/office/drawing/2014/main" id="{F448AAF6-1FCA-40DF-9F55-99946706E7DC}"/>
                    </a:ext>
                  </a:extLst>
                </p:cNvPr>
                <p:cNvSpPr/>
                <p:nvPr/>
              </p:nvSpPr>
              <p:spPr>
                <a:xfrm>
                  <a:off x="9043329" y="2873830"/>
                  <a:ext cx="593795" cy="448781"/>
                </a:xfrm>
                <a:custGeom>
                  <a:avLst/>
                  <a:gdLst>
                    <a:gd name="connsiteX0" fmla="*/ 181771 w 593795"/>
                    <a:gd name="connsiteY0" fmla="*/ 0 h 448781"/>
                    <a:gd name="connsiteX1" fmla="*/ 528995 w 593795"/>
                    <a:gd name="connsiteY1" fmla="*/ 106062 h 448781"/>
                    <a:gd name="connsiteX2" fmla="*/ 593795 w 593795"/>
                    <a:gd name="connsiteY2" fmla="*/ 159528 h 448781"/>
                    <a:gd name="connsiteX3" fmla="*/ 566685 w 593795"/>
                    <a:gd name="connsiteY3" fmla="*/ 181896 h 448781"/>
                    <a:gd name="connsiteX4" fmla="*/ 433593 w 593795"/>
                    <a:gd name="connsiteY4" fmla="*/ 379297 h 448781"/>
                    <a:gd name="connsiteX5" fmla="*/ 412024 w 593795"/>
                    <a:gd name="connsiteY5" fmla="*/ 448781 h 448781"/>
                    <a:gd name="connsiteX6" fmla="*/ 352062 w 593795"/>
                    <a:gd name="connsiteY6" fmla="*/ 430167 h 448781"/>
                    <a:gd name="connsiteX7" fmla="*/ 21569 w 593795"/>
                    <a:gd name="connsiteY7" fmla="*/ 99674 h 448781"/>
                    <a:gd name="connsiteX8" fmla="*/ 0 w 593795"/>
                    <a:gd name="connsiteY8" fmla="*/ 30191 h 448781"/>
                    <a:gd name="connsiteX9" fmla="*/ 56612 w 593795"/>
                    <a:gd name="connsiteY9" fmla="*/ 12617 h 448781"/>
                    <a:gd name="connsiteX10" fmla="*/ 181771 w 593795"/>
                    <a:gd name="connsiteY10" fmla="*/ 0 h 44878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</a:cxnLst>
                  <a:rect l="l" t="t" r="r" b="b"/>
                  <a:pathLst>
                    <a:path w="593795" h="448781">
                      <a:moveTo>
                        <a:pt x="181771" y="0"/>
                      </a:moveTo>
                      <a:cubicBezTo>
                        <a:pt x="310390" y="0"/>
                        <a:pt x="429878" y="39100"/>
                        <a:pt x="528995" y="106062"/>
                      </a:cubicBezTo>
                      <a:lnTo>
                        <a:pt x="593795" y="159528"/>
                      </a:lnTo>
                      <a:lnTo>
                        <a:pt x="566685" y="181896"/>
                      </a:lnTo>
                      <a:cubicBezTo>
                        <a:pt x="510492" y="238088"/>
                        <a:pt x="465019" y="304998"/>
                        <a:pt x="433593" y="379297"/>
                      </a:cubicBezTo>
                      <a:lnTo>
                        <a:pt x="412024" y="448781"/>
                      </a:lnTo>
                      <a:lnTo>
                        <a:pt x="352062" y="430167"/>
                      </a:lnTo>
                      <a:cubicBezTo>
                        <a:pt x="203464" y="367316"/>
                        <a:pt x="84420" y="248272"/>
                        <a:pt x="21569" y="99674"/>
                      </a:cubicBezTo>
                      <a:lnTo>
                        <a:pt x="0" y="30191"/>
                      </a:lnTo>
                      <a:lnTo>
                        <a:pt x="56612" y="12617"/>
                      </a:lnTo>
                      <a:cubicBezTo>
                        <a:pt x="97039" y="4345"/>
                        <a:pt x="138898" y="0"/>
                        <a:pt x="181771" y="0"/>
                      </a:cubicBezTo>
                      <a:close/>
                    </a:path>
                  </a:pathLst>
                </a:custGeom>
                <a:solidFill>
                  <a:srgbClr val="00FFFF">
                    <a:alpha val="74902"/>
                  </a:srgb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8576" tIns="19289" rIns="38576" bIns="19289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750"/>
                </a:p>
              </p:txBody>
            </p:sp>
            <p:sp>
              <p:nvSpPr>
                <p:cNvPr id="38" name="Freeform: Shape 37">
                  <a:extLst>
                    <a:ext uri="{FF2B5EF4-FFF2-40B4-BE49-F238E27FC236}">
                      <a16:creationId xmlns:a16="http://schemas.microsoft.com/office/drawing/2014/main" id="{D3AD551A-08AF-46B4-8240-AC1E8B2C41D3}"/>
                    </a:ext>
                  </a:extLst>
                </p:cNvPr>
                <p:cNvSpPr/>
                <p:nvPr/>
              </p:nvSpPr>
              <p:spPr>
                <a:xfrm>
                  <a:off x="9637124" y="2873830"/>
                  <a:ext cx="593795" cy="448781"/>
                </a:xfrm>
                <a:custGeom>
                  <a:avLst/>
                  <a:gdLst>
                    <a:gd name="connsiteX0" fmla="*/ 412024 w 593795"/>
                    <a:gd name="connsiteY0" fmla="*/ 0 h 448781"/>
                    <a:gd name="connsiteX1" fmla="*/ 537183 w 593795"/>
                    <a:gd name="connsiteY1" fmla="*/ 12617 h 448781"/>
                    <a:gd name="connsiteX2" fmla="*/ 593795 w 593795"/>
                    <a:gd name="connsiteY2" fmla="*/ 30191 h 448781"/>
                    <a:gd name="connsiteX3" fmla="*/ 572226 w 593795"/>
                    <a:gd name="connsiteY3" fmla="*/ 99674 h 448781"/>
                    <a:gd name="connsiteX4" fmla="*/ 241733 w 593795"/>
                    <a:gd name="connsiteY4" fmla="*/ 430167 h 448781"/>
                    <a:gd name="connsiteX5" fmla="*/ 181771 w 593795"/>
                    <a:gd name="connsiteY5" fmla="*/ 448781 h 448781"/>
                    <a:gd name="connsiteX6" fmla="*/ 160202 w 593795"/>
                    <a:gd name="connsiteY6" fmla="*/ 379297 h 448781"/>
                    <a:gd name="connsiteX7" fmla="*/ 27110 w 593795"/>
                    <a:gd name="connsiteY7" fmla="*/ 181896 h 448781"/>
                    <a:gd name="connsiteX8" fmla="*/ 0 w 593795"/>
                    <a:gd name="connsiteY8" fmla="*/ 159528 h 448781"/>
                    <a:gd name="connsiteX9" fmla="*/ 64800 w 593795"/>
                    <a:gd name="connsiteY9" fmla="*/ 106062 h 448781"/>
                    <a:gd name="connsiteX10" fmla="*/ 412024 w 593795"/>
                    <a:gd name="connsiteY10" fmla="*/ 0 h 44878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</a:cxnLst>
                  <a:rect l="l" t="t" r="r" b="b"/>
                  <a:pathLst>
                    <a:path w="593795" h="448781">
                      <a:moveTo>
                        <a:pt x="412024" y="0"/>
                      </a:moveTo>
                      <a:cubicBezTo>
                        <a:pt x="454897" y="0"/>
                        <a:pt x="496756" y="4345"/>
                        <a:pt x="537183" y="12617"/>
                      </a:cubicBezTo>
                      <a:lnTo>
                        <a:pt x="593795" y="30191"/>
                      </a:lnTo>
                      <a:lnTo>
                        <a:pt x="572226" y="99674"/>
                      </a:lnTo>
                      <a:cubicBezTo>
                        <a:pt x="509375" y="248272"/>
                        <a:pt x="390331" y="367316"/>
                        <a:pt x="241733" y="430167"/>
                      </a:cubicBezTo>
                      <a:lnTo>
                        <a:pt x="181771" y="448781"/>
                      </a:lnTo>
                      <a:lnTo>
                        <a:pt x="160202" y="379297"/>
                      </a:lnTo>
                      <a:cubicBezTo>
                        <a:pt x="128776" y="304998"/>
                        <a:pt x="83303" y="238088"/>
                        <a:pt x="27110" y="181896"/>
                      </a:cubicBezTo>
                      <a:lnTo>
                        <a:pt x="0" y="159528"/>
                      </a:lnTo>
                      <a:lnTo>
                        <a:pt x="64800" y="106062"/>
                      </a:lnTo>
                      <a:cubicBezTo>
                        <a:pt x="163917" y="39100"/>
                        <a:pt x="283405" y="0"/>
                        <a:pt x="412024" y="0"/>
                      </a:cubicBezTo>
                      <a:close/>
                    </a:path>
                  </a:pathLst>
                </a:custGeom>
                <a:solidFill>
                  <a:srgbClr val="FF9801">
                    <a:alpha val="74902"/>
                  </a:srgb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8576" tIns="19289" rIns="38576" bIns="19289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750"/>
                </a:p>
              </p:txBody>
            </p:sp>
            <p:sp>
              <p:nvSpPr>
                <p:cNvPr id="37" name="Freeform: Shape 36">
                  <a:extLst>
                    <a:ext uri="{FF2B5EF4-FFF2-40B4-BE49-F238E27FC236}">
                      <a16:creationId xmlns:a16="http://schemas.microsoft.com/office/drawing/2014/main" id="{B84725C0-D026-489F-9755-C8A9198903C2}"/>
                    </a:ext>
                  </a:extLst>
                </p:cNvPr>
                <p:cNvSpPr/>
                <p:nvPr/>
              </p:nvSpPr>
              <p:spPr>
                <a:xfrm>
                  <a:off x="9428117" y="3322611"/>
                  <a:ext cx="418012" cy="633751"/>
                </a:xfrm>
                <a:custGeom>
                  <a:avLst/>
                  <a:gdLst>
                    <a:gd name="connsiteX0" fmla="*/ 27235 w 418012"/>
                    <a:gd name="connsiteY0" fmla="*/ 0 h 633751"/>
                    <a:gd name="connsiteX1" fmla="*/ 83847 w 418012"/>
                    <a:gd name="connsiteY1" fmla="*/ 17573 h 633751"/>
                    <a:gd name="connsiteX2" fmla="*/ 209006 w 418012"/>
                    <a:gd name="connsiteY2" fmla="*/ 30190 h 633751"/>
                    <a:gd name="connsiteX3" fmla="*/ 334165 w 418012"/>
                    <a:gd name="connsiteY3" fmla="*/ 17573 h 633751"/>
                    <a:gd name="connsiteX4" fmla="*/ 390777 w 418012"/>
                    <a:gd name="connsiteY4" fmla="*/ 0 h 633751"/>
                    <a:gd name="connsiteX5" fmla="*/ 405395 w 418012"/>
                    <a:gd name="connsiteY5" fmla="*/ 47090 h 633751"/>
                    <a:gd name="connsiteX6" fmla="*/ 418012 w 418012"/>
                    <a:gd name="connsiteY6" fmla="*/ 172249 h 633751"/>
                    <a:gd name="connsiteX7" fmla="*/ 236116 w 418012"/>
                    <a:gd name="connsiteY7" fmla="*/ 611383 h 633751"/>
                    <a:gd name="connsiteX8" fmla="*/ 209006 w 418012"/>
                    <a:gd name="connsiteY8" fmla="*/ 633751 h 633751"/>
                    <a:gd name="connsiteX9" fmla="*/ 181896 w 418012"/>
                    <a:gd name="connsiteY9" fmla="*/ 611383 h 633751"/>
                    <a:gd name="connsiteX10" fmla="*/ 0 w 418012"/>
                    <a:gd name="connsiteY10" fmla="*/ 172249 h 633751"/>
                    <a:gd name="connsiteX11" fmla="*/ 12617 w 418012"/>
                    <a:gd name="connsiteY11" fmla="*/ 47090 h 633751"/>
                    <a:gd name="connsiteX12" fmla="*/ 27235 w 418012"/>
                    <a:gd name="connsiteY12" fmla="*/ 0 h 63375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</a:cxnLst>
                  <a:rect l="l" t="t" r="r" b="b"/>
                  <a:pathLst>
                    <a:path w="418012" h="633751">
                      <a:moveTo>
                        <a:pt x="27235" y="0"/>
                      </a:moveTo>
                      <a:lnTo>
                        <a:pt x="83847" y="17573"/>
                      </a:lnTo>
                      <a:cubicBezTo>
                        <a:pt x="124274" y="25846"/>
                        <a:pt x="166133" y="30190"/>
                        <a:pt x="209006" y="30190"/>
                      </a:cubicBezTo>
                      <a:cubicBezTo>
                        <a:pt x="251879" y="30190"/>
                        <a:pt x="293738" y="25846"/>
                        <a:pt x="334165" y="17573"/>
                      </a:cubicBezTo>
                      <a:lnTo>
                        <a:pt x="390777" y="0"/>
                      </a:lnTo>
                      <a:lnTo>
                        <a:pt x="405395" y="47090"/>
                      </a:lnTo>
                      <a:cubicBezTo>
                        <a:pt x="413668" y="87518"/>
                        <a:pt x="418012" y="129376"/>
                        <a:pt x="418012" y="172249"/>
                      </a:cubicBezTo>
                      <a:cubicBezTo>
                        <a:pt x="418012" y="343742"/>
                        <a:pt x="348501" y="498999"/>
                        <a:pt x="236116" y="611383"/>
                      </a:cubicBezTo>
                      <a:lnTo>
                        <a:pt x="209006" y="633751"/>
                      </a:lnTo>
                      <a:lnTo>
                        <a:pt x="181896" y="611383"/>
                      </a:lnTo>
                      <a:cubicBezTo>
                        <a:pt x="69511" y="498999"/>
                        <a:pt x="0" y="343742"/>
                        <a:pt x="0" y="172249"/>
                      </a:cubicBezTo>
                      <a:cubicBezTo>
                        <a:pt x="0" y="129376"/>
                        <a:pt x="4344" y="87518"/>
                        <a:pt x="12617" y="47090"/>
                      </a:cubicBezTo>
                      <a:lnTo>
                        <a:pt x="27235" y="0"/>
                      </a:lnTo>
                      <a:close/>
                    </a:path>
                  </a:pathLst>
                </a:custGeom>
                <a:solidFill>
                  <a:srgbClr val="000000">
                    <a:alpha val="74902"/>
                  </a:srgb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8576" tIns="19289" rIns="38576" bIns="19289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750"/>
                </a:p>
              </p:txBody>
            </p:sp>
            <p:sp>
              <p:nvSpPr>
                <p:cNvPr id="36" name="Freeform: Shape 35">
                  <a:extLst>
                    <a:ext uri="{FF2B5EF4-FFF2-40B4-BE49-F238E27FC236}">
                      <a16:creationId xmlns:a16="http://schemas.microsoft.com/office/drawing/2014/main" id="{DCB92921-151E-4D4C-99A5-ED8F5620E7B3}"/>
                    </a:ext>
                  </a:extLst>
                </p:cNvPr>
                <p:cNvSpPr/>
                <p:nvPr/>
              </p:nvSpPr>
              <p:spPr>
                <a:xfrm>
                  <a:off x="9016093" y="2110741"/>
                  <a:ext cx="1242060" cy="922617"/>
                </a:xfrm>
                <a:custGeom>
                  <a:avLst/>
                  <a:gdLst>
                    <a:gd name="connsiteX0" fmla="*/ 621030 w 1242060"/>
                    <a:gd name="connsiteY0" fmla="*/ 0 h 922617"/>
                    <a:gd name="connsiteX1" fmla="*/ 1242060 w 1242060"/>
                    <a:gd name="connsiteY1" fmla="*/ 621030 h 922617"/>
                    <a:gd name="connsiteX2" fmla="*/ 1229443 w 1242060"/>
                    <a:gd name="connsiteY2" fmla="*/ 746189 h 922617"/>
                    <a:gd name="connsiteX3" fmla="*/ 1214825 w 1242060"/>
                    <a:gd name="connsiteY3" fmla="*/ 793280 h 922617"/>
                    <a:gd name="connsiteX4" fmla="*/ 1158213 w 1242060"/>
                    <a:gd name="connsiteY4" fmla="*/ 775706 h 922617"/>
                    <a:gd name="connsiteX5" fmla="*/ 1033054 w 1242060"/>
                    <a:gd name="connsiteY5" fmla="*/ 763089 h 922617"/>
                    <a:gd name="connsiteX6" fmla="*/ 685830 w 1242060"/>
                    <a:gd name="connsiteY6" fmla="*/ 869151 h 922617"/>
                    <a:gd name="connsiteX7" fmla="*/ 621030 w 1242060"/>
                    <a:gd name="connsiteY7" fmla="*/ 922617 h 922617"/>
                    <a:gd name="connsiteX8" fmla="*/ 556230 w 1242060"/>
                    <a:gd name="connsiteY8" fmla="*/ 869151 h 922617"/>
                    <a:gd name="connsiteX9" fmla="*/ 209006 w 1242060"/>
                    <a:gd name="connsiteY9" fmla="*/ 763089 h 922617"/>
                    <a:gd name="connsiteX10" fmla="*/ 83847 w 1242060"/>
                    <a:gd name="connsiteY10" fmla="*/ 775706 h 922617"/>
                    <a:gd name="connsiteX11" fmla="*/ 27235 w 1242060"/>
                    <a:gd name="connsiteY11" fmla="*/ 793280 h 922617"/>
                    <a:gd name="connsiteX12" fmla="*/ 12617 w 1242060"/>
                    <a:gd name="connsiteY12" fmla="*/ 746189 h 922617"/>
                    <a:gd name="connsiteX13" fmla="*/ 0 w 1242060"/>
                    <a:gd name="connsiteY13" fmla="*/ 621030 h 922617"/>
                    <a:gd name="connsiteX14" fmla="*/ 621030 w 1242060"/>
                    <a:gd name="connsiteY14" fmla="*/ 0 h 922617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</a:cxnLst>
                  <a:rect l="l" t="t" r="r" b="b"/>
                  <a:pathLst>
                    <a:path w="1242060" h="922617">
                      <a:moveTo>
                        <a:pt x="621030" y="0"/>
                      </a:moveTo>
                      <a:cubicBezTo>
                        <a:pt x="964015" y="0"/>
                        <a:pt x="1242060" y="278045"/>
                        <a:pt x="1242060" y="621030"/>
                      </a:cubicBezTo>
                      <a:cubicBezTo>
                        <a:pt x="1242060" y="663903"/>
                        <a:pt x="1237716" y="705762"/>
                        <a:pt x="1229443" y="746189"/>
                      </a:cubicBezTo>
                      <a:lnTo>
                        <a:pt x="1214825" y="793280"/>
                      </a:lnTo>
                      <a:lnTo>
                        <a:pt x="1158213" y="775706"/>
                      </a:lnTo>
                      <a:cubicBezTo>
                        <a:pt x="1117786" y="767434"/>
                        <a:pt x="1075927" y="763089"/>
                        <a:pt x="1033054" y="763089"/>
                      </a:cubicBezTo>
                      <a:cubicBezTo>
                        <a:pt x="904435" y="763089"/>
                        <a:pt x="784947" y="802189"/>
                        <a:pt x="685830" y="869151"/>
                      </a:cubicBezTo>
                      <a:lnTo>
                        <a:pt x="621030" y="922617"/>
                      </a:lnTo>
                      <a:lnTo>
                        <a:pt x="556230" y="869151"/>
                      </a:lnTo>
                      <a:cubicBezTo>
                        <a:pt x="457113" y="802189"/>
                        <a:pt x="337625" y="763089"/>
                        <a:pt x="209006" y="763089"/>
                      </a:cubicBezTo>
                      <a:cubicBezTo>
                        <a:pt x="166133" y="763089"/>
                        <a:pt x="124274" y="767434"/>
                        <a:pt x="83847" y="775706"/>
                      </a:cubicBezTo>
                      <a:lnTo>
                        <a:pt x="27235" y="793280"/>
                      </a:lnTo>
                      <a:lnTo>
                        <a:pt x="12617" y="746189"/>
                      </a:lnTo>
                      <a:cubicBezTo>
                        <a:pt x="4344" y="705762"/>
                        <a:pt x="0" y="663903"/>
                        <a:pt x="0" y="621030"/>
                      </a:cubicBezTo>
                      <a:cubicBezTo>
                        <a:pt x="0" y="278045"/>
                        <a:pt x="278045" y="0"/>
                        <a:pt x="621030" y="0"/>
                      </a:cubicBezTo>
                      <a:close/>
                    </a:path>
                  </a:pathLst>
                </a:custGeom>
                <a:solidFill>
                  <a:srgbClr val="007A73">
                    <a:alpha val="74902"/>
                  </a:srgb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8576" tIns="19289" rIns="38576" bIns="19289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r>
                    <a:rPr lang="en-US" sz="75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7A9 footprint</a:t>
                  </a:r>
                </a:p>
              </p:txBody>
            </p:sp>
            <p:sp>
              <p:nvSpPr>
                <p:cNvPr id="35" name="Freeform: Shape 34">
                  <a:extLst>
                    <a:ext uri="{FF2B5EF4-FFF2-40B4-BE49-F238E27FC236}">
                      <a16:creationId xmlns:a16="http://schemas.microsoft.com/office/drawing/2014/main" id="{9FD2C3B7-0DBB-416E-88C1-687E359A8F6F}"/>
                    </a:ext>
                  </a:extLst>
                </p:cNvPr>
                <p:cNvSpPr/>
                <p:nvPr/>
              </p:nvSpPr>
              <p:spPr>
                <a:xfrm>
                  <a:off x="8604069" y="2904021"/>
                  <a:ext cx="1033054" cy="1211869"/>
                </a:xfrm>
                <a:custGeom>
                  <a:avLst/>
                  <a:gdLst>
                    <a:gd name="connsiteX0" fmla="*/ 439259 w 1033054"/>
                    <a:gd name="connsiteY0" fmla="*/ 0 h 1211869"/>
                    <a:gd name="connsiteX1" fmla="*/ 460828 w 1033054"/>
                    <a:gd name="connsiteY1" fmla="*/ 69483 h 1211869"/>
                    <a:gd name="connsiteX2" fmla="*/ 791321 w 1033054"/>
                    <a:gd name="connsiteY2" fmla="*/ 399976 h 1211869"/>
                    <a:gd name="connsiteX3" fmla="*/ 851283 w 1033054"/>
                    <a:gd name="connsiteY3" fmla="*/ 418590 h 1211869"/>
                    <a:gd name="connsiteX4" fmla="*/ 836665 w 1033054"/>
                    <a:gd name="connsiteY4" fmla="*/ 465680 h 1211869"/>
                    <a:gd name="connsiteX5" fmla="*/ 824048 w 1033054"/>
                    <a:gd name="connsiteY5" fmla="*/ 590839 h 1211869"/>
                    <a:gd name="connsiteX6" fmla="*/ 1005944 w 1033054"/>
                    <a:gd name="connsiteY6" fmla="*/ 1029973 h 1211869"/>
                    <a:gd name="connsiteX7" fmla="*/ 1033054 w 1033054"/>
                    <a:gd name="connsiteY7" fmla="*/ 1052341 h 1211869"/>
                    <a:gd name="connsiteX8" fmla="*/ 968254 w 1033054"/>
                    <a:gd name="connsiteY8" fmla="*/ 1105807 h 1211869"/>
                    <a:gd name="connsiteX9" fmla="*/ 621030 w 1033054"/>
                    <a:gd name="connsiteY9" fmla="*/ 1211869 h 1211869"/>
                    <a:gd name="connsiteX10" fmla="*/ 0 w 1033054"/>
                    <a:gd name="connsiteY10" fmla="*/ 590839 h 1211869"/>
                    <a:gd name="connsiteX11" fmla="*/ 379297 w 1033054"/>
                    <a:gd name="connsiteY11" fmla="*/ 18613 h 1211869"/>
                    <a:gd name="connsiteX12" fmla="*/ 439259 w 1033054"/>
                    <a:gd name="connsiteY12" fmla="*/ 0 h 12118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</a:cxnLst>
                  <a:rect l="l" t="t" r="r" b="b"/>
                  <a:pathLst>
                    <a:path w="1033054" h="1211869">
                      <a:moveTo>
                        <a:pt x="439259" y="0"/>
                      </a:moveTo>
                      <a:lnTo>
                        <a:pt x="460828" y="69483"/>
                      </a:lnTo>
                      <a:cubicBezTo>
                        <a:pt x="523679" y="218081"/>
                        <a:pt x="642723" y="337125"/>
                        <a:pt x="791321" y="399976"/>
                      </a:cubicBezTo>
                      <a:lnTo>
                        <a:pt x="851283" y="418590"/>
                      </a:lnTo>
                      <a:lnTo>
                        <a:pt x="836665" y="465680"/>
                      </a:lnTo>
                      <a:cubicBezTo>
                        <a:pt x="828392" y="506108"/>
                        <a:pt x="824048" y="547966"/>
                        <a:pt x="824048" y="590839"/>
                      </a:cubicBezTo>
                      <a:cubicBezTo>
                        <a:pt x="824048" y="762332"/>
                        <a:pt x="893559" y="917589"/>
                        <a:pt x="1005944" y="1029973"/>
                      </a:cubicBezTo>
                      <a:lnTo>
                        <a:pt x="1033054" y="1052341"/>
                      </a:lnTo>
                      <a:lnTo>
                        <a:pt x="968254" y="1105807"/>
                      </a:lnTo>
                      <a:cubicBezTo>
                        <a:pt x="869137" y="1172769"/>
                        <a:pt x="749649" y="1211869"/>
                        <a:pt x="621030" y="1211869"/>
                      </a:cubicBezTo>
                      <a:cubicBezTo>
                        <a:pt x="278045" y="1211869"/>
                        <a:pt x="0" y="933824"/>
                        <a:pt x="0" y="590839"/>
                      </a:cubicBezTo>
                      <a:cubicBezTo>
                        <a:pt x="0" y="333600"/>
                        <a:pt x="156400" y="112890"/>
                        <a:pt x="379297" y="18613"/>
                      </a:cubicBezTo>
                      <a:lnTo>
                        <a:pt x="439259" y="0"/>
                      </a:lnTo>
                      <a:close/>
                    </a:path>
                  </a:pathLst>
                </a:custGeom>
                <a:solidFill>
                  <a:srgbClr val="AFEFB4">
                    <a:alpha val="74902"/>
                  </a:srgb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8576" tIns="19289" rIns="38576" bIns="19289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r>
                    <a:rPr lang="en-US" sz="75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</a:p>
              </p:txBody>
            </p:sp>
            <p:sp>
              <p:nvSpPr>
                <p:cNvPr id="34" name="Freeform: Shape 33">
                  <a:extLst>
                    <a:ext uri="{FF2B5EF4-FFF2-40B4-BE49-F238E27FC236}">
                      <a16:creationId xmlns:a16="http://schemas.microsoft.com/office/drawing/2014/main" id="{F79BD952-D136-4073-B8B4-91FA0F3EA9DA}"/>
                    </a:ext>
                  </a:extLst>
                </p:cNvPr>
                <p:cNvSpPr/>
                <p:nvPr/>
              </p:nvSpPr>
              <p:spPr>
                <a:xfrm>
                  <a:off x="9637123" y="2904020"/>
                  <a:ext cx="1033054" cy="1211870"/>
                </a:xfrm>
                <a:custGeom>
                  <a:avLst/>
                  <a:gdLst>
                    <a:gd name="connsiteX0" fmla="*/ 593795 w 1033054"/>
                    <a:gd name="connsiteY0" fmla="*/ 0 h 1211869"/>
                    <a:gd name="connsiteX1" fmla="*/ 653757 w 1033054"/>
                    <a:gd name="connsiteY1" fmla="*/ 18613 h 1211869"/>
                    <a:gd name="connsiteX2" fmla="*/ 1033054 w 1033054"/>
                    <a:gd name="connsiteY2" fmla="*/ 590839 h 1211869"/>
                    <a:gd name="connsiteX3" fmla="*/ 412024 w 1033054"/>
                    <a:gd name="connsiteY3" fmla="*/ 1211869 h 1211869"/>
                    <a:gd name="connsiteX4" fmla="*/ 64800 w 1033054"/>
                    <a:gd name="connsiteY4" fmla="*/ 1105807 h 1211869"/>
                    <a:gd name="connsiteX5" fmla="*/ 0 w 1033054"/>
                    <a:gd name="connsiteY5" fmla="*/ 1052341 h 1211869"/>
                    <a:gd name="connsiteX6" fmla="*/ 27110 w 1033054"/>
                    <a:gd name="connsiteY6" fmla="*/ 1029973 h 1211869"/>
                    <a:gd name="connsiteX7" fmla="*/ 209006 w 1033054"/>
                    <a:gd name="connsiteY7" fmla="*/ 590839 h 1211869"/>
                    <a:gd name="connsiteX8" fmla="*/ 196389 w 1033054"/>
                    <a:gd name="connsiteY8" fmla="*/ 465680 h 1211869"/>
                    <a:gd name="connsiteX9" fmla="*/ 181771 w 1033054"/>
                    <a:gd name="connsiteY9" fmla="*/ 418590 h 1211869"/>
                    <a:gd name="connsiteX10" fmla="*/ 241733 w 1033054"/>
                    <a:gd name="connsiteY10" fmla="*/ 399976 h 1211869"/>
                    <a:gd name="connsiteX11" fmla="*/ 572226 w 1033054"/>
                    <a:gd name="connsiteY11" fmla="*/ 69483 h 1211869"/>
                    <a:gd name="connsiteX12" fmla="*/ 593795 w 1033054"/>
                    <a:gd name="connsiteY12" fmla="*/ 0 h 121186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</a:cxnLst>
                  <a:rect l="l" t="t" r="r" b="b"/>
                  <a:pathLst>
                    <a:path w="1033054" h="1211869">
                      <a:moveTo>
                        <a:pt x="593795" y="0"/>
                      </a:moveTo>
                      <a:lnTo>
                        <a:pt x="653757" y="18613"/>
                      </a:lnTo>
                      <a:cubicBezTo>
                        <a:pt x="876654" y="112890"/>
                        <a:pt x="1033054" y="333600"/>
                        <a:pt x="1033054" y="590839"/>
                      </a:cubicBezTo>
                      <a:cubicBezTo>
                        <a:pt x="1033054" y="933824"/>
                        <a:pt x="755009" y="1211869"/>
                        <a:pt x="412024" y="1211869"/>
                      </a:cubicBezTo>
                      <a:cubicBezTo>
                        <a:pt x="283405" y="1211869"/>
                        <a:pt x="163917" y="1172769"/>
                        <a:pt x="64800" y="1105807"/>
                      </a:cubicBezTo>
                      <a:lnTo>
                        <a:pt x="0" y="1052341"/>
                      </a:lnTo>
                      <a:lnTo>
                        <a:pt x="27110" y="1029973"/>
                      </a:lnTo>
                      <a:cubicBezTo>
                        <a:pt x="139495" y="917589"/>
                        <a:pt x="209006" y="762332"/>
                        <a:pt x="209006" y="590839"/>
                      </a:cubicBezTo>
                      <a:cubicBezTo>
                        <a:pt x="209006" y="547966"/>
                        <a:pt x="204662" y="506108"/>
                        <a:pt x="196389" y="465680"/>
                      </a:cubicBezTo>
                      <a:lnTo>
                        <a:pt x="181771" y="418590"/>
                      </a:lnTo>
                      <a:lnTo>
                        <a:pt x="241733" y="399976"/>
                      </a:lnTo>
                      <a:cubicBezTo>
                        <a:pt x="390331" y="337125"/>
                        <a:pt x="509375" y="218081"/>
                        <a:pt x="572226" y="69483"/>
                      </a:cubicBezTo>
                      <a:lnTo>
                        <a:pt x="593795" y="0"/>
                      </a:lnTo>
                      <a:close/>
                    </a:path>
                  </a:pathLst>
                </a:custGeom>
                <a:solidFill>
                  <a:srgbClr val="FFFF99">
                    <a:alpha val="74902"/>
                  </a:srgb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8576" tIns="19289" rIns="38576" bIns="19289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r>
                    <a:rPr lang="en-US" sz="75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</a:t>
                  </a:r>
                </a:p>
              </p:txBody>
            </p:sp>
            <p:sp>
              <p:nvSpPr>
                <p:cNvPr id="33" name="Freeform: Shape 32">
                  <a:extLst>
                    <a:ext uri="{FF2B5EF4-FFF2-40B4-BE49-F238E27FC236}">
                      <a16:creationId xmlns:a16="http://schemas.microsoft.com/office/drawing/2014/main" id="{DB35AB52-93FA-4795-B8DA-6D5F1225F01A}"/>
                    </a:ext>
                  </a:extLst>
                </p:cNvPr>
                <p:cNvSpPr/>
                <p:nvPr/>
              </p:nvSpPr>
              <p:spPr>
                <a:xfrm>
                  <a:off x="9455352" y="3033358"/>
                  <a:ext cx="363542" cy="319443"/>
                </a:xfrm>
                <a:custGeom>
                  <a:avLst/>
                  <a:gdLst>
                    <a:gd name="connsiteX0" fmla="*/ 181771 w 363542"/>
                    <a:gd name="connsiteY0" fmla="*/ 0 h 319443"/>
                    <a:gd name="connsiteX1" fmla="*/ 208881 w 363542"/>
                    <a:gd name="connsiteY1" fmla="*/ 22368 h 319443"/>
                    <a:gd name="connsiteX2" fmla="*/ 341973 w 363542"/>
                    <a:gd name="connsiteY2" fmla="*/ 219769 h 319443"/>
                    <a:gd name="connsiteX3" fmla="*/ 363542 w 363542"/>
                    <a:gd name="connsiteY3" fmla="*/ 289253 h 319443"/>
                    <a:gd name="connsiteX4" fmla="*/ 306930 w 363542"/>
                    <a:gd name="connsiteY4" fmla="*/ 306826 h 319443"/>
                    <a:gd name="connsiteX5" fmla="*/ 181771 w 363542"/>
                    <a:gd name="connsiteY5" fmla="*/ 319443 h 319443"/>
                    <a:gd name="connsiteX6" fmla="*/ 56612 w 363542"/>
                    <a:gd name="connsiteY6" fmla="*/ 306826 h 319443"/>
                    <a:gd name="connsiteX7" fmla="*/ 0 w 363542"/>
                    <a:gd name="connsiteY7" fmla="*/ 289253 h 319443"/>
                    <a:gd name="connsiteX8" fmla="*/ 21569 w 363542"/>
                    <a:gd name="connsiteY8" fmla="*/ 219769 h 319443"/>
                    <a:gd name="connsiteX9" fmla="*/ 154661 w 363542"/>
                    <a:gd name="connsiteY9" fmla="*/ 22368 h 319443"/>
                    <a:gd name="connsiteX10" fmla="*/ 181771 w 363542"/>
                    <a:gd name="connsiteY10" fmla="*/ 0 h 31944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</a:cxnLst>
                  <a:rect l="l" t="t" r="r" b="b"/>
                  <a:pathLst>
                    <a:path w="363542" h="319443">
                      <a:moveTo>
                        <a:pt x="181771" y="0"/>
                      </a:moveTo>
                      <a:lnTo>
                        <a:pt x="208881" y="22368"/>
                      </a:lnTo>
                      <a:cubicBezTo>
                        <a:pt x="265074" y="78560"/>
                        <a:pt x="310547" y="145470"/>
                        <a:pt x="341973" y="219769"/>
                      </a:cubicBezTo>
                      <a:lnTo>
                        <a:pt x="363542" y="289253"/>
                      </a:lnTo>
                      <a:lnTo>
                        <a:pt x="306930" y="306826"/>
                      </a:lnTo>
                      <a:cubicBezTo>
                        <a:pt x="266503" y="315099"/>
                        <a:pt x="224644" y="319443"/>
                        <a:pt x="181771" y="319443"/>
                      </a:cubicBezTo>
                      <a:cubicBezTo>
                        <a:pt x="138898" y="319443"/>
                        <a:pt x="97039" y="315099"/>
                        <a:pt x="56612" y="306826"/>
                      </a:cubicBezTo>
                      <a:lnTo>
                        <a:pt x="0" y="289253"/>
                      </a:lnTo>
                      <a:lnTo>
                        <a:pt x="21569" y="219769"/>
                      </a:lnTo>
                      <a:cubicBezTo>
                        <a:pt x="52995" y="145470"/>
                        <a:pt x="98468" y="78560"/>
                        <a:pt x="154661" y="22368"/>
                      </a:cubicBezTo>
                      <a:lnTo>
                        <a:pt x="181771" y="0"/>
                      </a:lnTo>
                      <a:close/>
                    </a:path>
                  </a:pathLst>
                </a:custGeom>
                <a:solidFill>
                  <a:srgbClr val="000000">
                    <a:alpha val="74902"/>
                  </a:srgb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38576" tIns="19289" rIns="38576" bIns="19289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en-US" sz="750"/>
                </a:p>
              </p:txBody>
            </p:sp>
          </p:grp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02834274-950F-4694-BE4C-9D13F1DC0315}"/>
                  </a:ext>
                </a:extLst>
              </p:cNvPr>
              <p:cNvSpPr txBox="1"/>
              <p:nvPr/>
            </p:nvSpPr>
            <p:spPr>
              <a:xfrm>
                <a:off x="3713961" y="4358423"/>
                <a:ext cx="716518" cy="4349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50" dirty="0">
                    <a:solidFill>
                      <a:srgbClr val="FF980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355, R357, Y396, P463, F464, E516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8C5962BE-404C-4C41-85B7-BA028D362123}"/>
                  </a:ext>
                </a:extLst>
              </p:cNvPr>
              <p:cNvSpPr txBox="1"/>
              <p:nvPr/>
            </p:nvSpPr>
            <p:spPr>
              <a:xfrm>
                <a:off x="2446765" y="4344262"/>
                <a:ext cx="713737" cy="4349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50" dirty="0">
                    <a:solidFill>
                      <a:srgbClr val="00DFDA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353, N354, R355, R357, E465 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DA11ED02-44B3-4BF6-AFCE-43E61ED1FC0C}"/>
                  </a:ext>
                </a:extLst>
              </p:cNvPr>
              <p:cNvSpPr txBox="1"/>
              <p:nvPr/>
            </p:nvSpPr>
            <p:spPr>
              <a:xfrm>
                <a:off x="3071645" y="5381603"/>
                <a:ext cx="721013" cy="2060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50" dirty="0">
                    <a:latin typeface="Arial" panose="020B0604020202020204" pitchFamily="34" charset="0"/>
                    <a:cs typeface="Arial" panose="020B0604020202020204" pitchFamily="34" charset="0"/>
                  </a:rPr>
                  <a:t>R355, R357</a:t>
                </a:r>
              </a:p>
            </p:txBody>
          </p:sp>
        </p:grp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44A4CE74-B2CC-4E29-84C1-1D6F4F9848C6}"/>
                </a:ext>
              </a:extLst>
            </p:cNvPr>
            <p:cNvSpPr txBox="1"/>
            <p:nvPr/>
          </p:nvSpPr>
          <p:spPr>
            <a:xfrm>
              <a:off x="4828728" y="7413590"/>
              <a:ext cx="874031" cy="5340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553-49 footprint</a:t>
              </a:r>
              <a:endParaRPr lang="en-US" sz="750" dirty="0"/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E5399F3C-E134-4DDE-9F60-68827475BA2F}"/>
                </a:ext>
              </a:extLst>
            </p:cNvPr>
            <p:cNvSpPr txBox="1"/>
            <p:nvPr/>
          </p:nvSpPr>
          <p:spPr>
            <a:xfrm>
              <a:off x="5872697" y="7324705"/>
              <a:ext cx="934814" cy="7248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dirty="0">
                  <a:latin typeface="Arial" panose="020B0604020202020204" pitchFamily="34" charset="0"/>
                  <a:cs typeface="Arial" panose="020B0604020202020204" pitchFamily="34" charset="0"/>
                </a:rPr>
                <a:t>bn03 n3130v   footprint</a:t>
              </a:r>
              <a:endParaRPr lang="en-US" sz="750" dirty="0"/>
            </a:p>
          </p:txBody>
        </p:sp>
      </p:grpSp>
      <p:sp>
        <p:nvSpPr>
          <p:cNvPr id="64" name="TextBox 63">
            <a:extLst>
              <a:ext uri="{FF2B5EF4-FFF2-40B4-BE49-F238E27FC236}">
                <a16:creationId xmlns:a16="http://schemas.microsoft.com/office/drawing/2014/main" id="{9A374EDC-5A7C-445A-86B8-9C3CB66AEC75}"/>
              </a:ext>
            </a:extLst>
          </p:cNvPr>
          <p:cNvSpPr txBox="1"/>
          <p:nvPr/>
        </p:nvSpPr>
        <p:spPr>
          <a:xfrm>
            <a:off x="1263540" y="289235"/>
            <a:ext cx="678391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>
                <a:solidFill>
                  <a:srgbClr val="69E172"/>
                </a:solidFill>
              </a:rPr>
              <a:t>553-49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DECDB8A-D75D-432F-8415-774E4CF875C0}"/>
              </a:ext>
            </a:extLst>
          </p:cNvPr>
          <p:cNvSpPr txBox="1"/>
          <p:nvPr/>
        </p:nvSpPr>
        <p:spPr>
          <a:xfrm>
            <a:off x="3222097" y="286570"/>
            <a:ext cx="46038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>
                <a:solidFill>
                  <a:srgbClr val="007A73"/>
                </a:solidFill>
              </a:rPr>
              <a:t>7A9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118E973D-AB54-4FE8-BDA6-431FB63E38E5}"/>
              </a:ext>
            </a:extLst>
          </p:cNvPr>
          <p:cNvSpPr txBox="1"/>
          <p:nvPr/>
        </p:nvSpPr>
        <p:spPr>
          <a:xfrm>
            <a:off x="4773763" y="289235"/>
            <a:ext cx="110479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dirty="0">
                <a:solidFill>
                  <a:srgbClr val="C9C400"/>
                </a:solidFill>
              </a:rPr>
              <a:t>bn03 n3130v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C82A26B-203A-4A5B-888E-68065A43F90B}"/>
              </a:ext>
            </a:extLst>
          </p:cNvPr>
          <p:cNvSpPr txBox="1"/>
          <p:nvPr/>
        </p:nvSpPr>
        <p:spPr>
          <a:xfrm>
            <a:off x="220579" y="7609818"/>
            <a:ext cx="6416842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+mj-lt"/>
              </a:rPr>
              <a:t>Supplementary Figure 6</a:t>
            </a:r>
            <a:r>
              <a:rPr lang="en-US" sz="1100" dirty="0">
                <a:latin typeface="+mj-lt"/>
              </a:rPr>
              <a:t>. </a:t>
            </a:r>
            <a:r>
              <a:rPr lang="en-US" sz="1100" dirty="0"/>
              <a:t>Comparison of 7A9 with 553-49 Fab and bn03 n3130v VHH. </a:t>
            </a:r>
            <a:r>
              <a:rPr lang="en-US" sz="1100" b="1" dirty="0"/>
              <a:t>A. </a:t>
            </a:r>
            <a:r>
              <a:rPr lang="en-US" sz="1100" dirty="0"/>
              <a:t>Structures of 553-49 (left, PDBID: 7WOG), 7A9 (middle), and bn03 n3130v (right, PDBID: 7WHJ) bound to the SARS-CoV2 Spike RBD. </a:t>
            </a:r>
            <a:r>
              <a:rPr lang="en-US" sz="1100" b="1" dirty="0"/>
              <a:t>B. </a:t>
            </a:r>
            <a:r>
              <a:rPr lang="en-US" sz="1100" dirty="0"/>
              <a:t>Epitopes of 553-49 (left), 7A9 (middle), and bn03 n3130v (right) on the RBD using a 3.5 Å distance cutoff. </a:t>
            </a:r>
            <a:r>
              <a:rPr lang="en-US" sz="1100" b="1" dirty="0"/>
              <a:t>C. </a:t>
            </a:r>
            <a:r>
              <a:rPr lang="en-US" sz="1100" dirty="0"/>
              <a:t>Left: Overlay of the epitopes of 553-49 and 7A9 with common residues colored cyan. Middle-Left: Overlay of the epitopes of bn03 n3130v and 7A9 with common residues colored orange. Middle-right: Overlay of the epitopes of all three antibodies with common residues colored black. Right: Summary of shared epitope residues between the three antibodies. </a:t>
            </a:r>
            <a:r>
              <a:rPr lang="en-US" sz="1100" b="1" dirty="0"/>
              <a:t>D. </a:t>
            </a:r>
            <a:r>
              <a:rPr lang="en-US" sz="1100" dirty="0"/>
              <a:t>Details of interactions made between RBD residues R355 and R357 with 553-49 (left), 7A9 (middle), and bn03 n3130v (right).</a:t>
            </a:r>
          </a:p>
        </p:txBody>
      </p:sp>
    </p:spTree>
    <p:extLst>
      <p:ext uri="{BB962C8B-B14F-4D97-AF65-F5344CB8AC3E}">
        <p14:creationId xmlns:p14="http://schemas.microsoft.com/office/powerpoint/2010/main" val="6863399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512FC5133423649B55DE7C5401660E1" ma:contentTypeVersion="11" ma:contentTypeDescription="Create a new document." ma:contentTypeScope="" ma:versionID="9eaaeb55820e8a2adcdd45be8b1855b2">
  <xsd:schema xmlns:xsd="http://www.w3.org/2001/XMLSchema" xmlns:xs="http://www.w3.org/2001/XMLSchema" xmlns:p="http://schemas.microsoft.com/office/2006/metadata/properties" xmlns:ns2="622ddcfb-fa2d-405b-8be9-6cb9627a9aac" xmlns:ns3="a8fda7bf-bf9a-4f4b-adf1-cb7b47dd83e9" targetNamespace="http://schemas.microsoft.com/office/2006/metadata/properties" ma:root="true" ma:fieldsID="aa98f1e2f4f0d9f68d1485c2afebaf80" ns2:_="" ns3:_="">
    <xsd:import namespace="622ddcfb-fa2d-405b-8be9-6cb9627a9aac"/>
    <xsd:import namespace="a8fda7bf-bf9a-4f4b-adf1-cb7b47dd83e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22ddcfb-fa2d-405b-8be9-6cb9627a9aa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2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3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ObjectDetectorVersions" ma:index="18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8fda7bf-bf9a-4f4b-adf1-cb7b47dd83e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E17B6C8-7EDE-4A5A-BA79-8EDCC39A307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22ddcfb-fa2d-405b-8be9-6cb9627a9aac"/>
    <ds:schemaRef ds:uri="a8fda7bf-bf9a-4f4b-adf1-cb7b47dd83e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B825C4E-3560-4262-970D-46F09992630A}">
  <ds:schemaRefs>
    <ds:schemaRef ds:uri="http://purl.org/dc/dcmitype/"/>
    <ds:schemaRef ds:uri="http://schemas.microsoft.com/office/2006/metadata/properties"/>
    <ds:schemaRef ds:uri="http://schemas.microsoft.com/office/2006/documentManagement/types"/>
    <ds:schemaRef ds:uri="http://purl.org/dc/elements/1.1/"/>
    <ds:schemaRef ds:uri="622ddcfb-fa2d-405b-8be9-6cb9627a9aac"/>
    <ds:schemaRef ds:uri="http://schemas.openxmlformats.org/package/2006/metadata/core-properties"/>
    <ds:schemaRef ds:uri="http://purl.org/dc/terms/"/>
    <ds:schemaRef ds:uri="http://schemas.microsoft.com/office/infopath/2007/PartnerControls"/>
    <ds:schemaRef ds:uri="a8fda7bf-bf9a-4f4b-adf1-cb7b47dd83e9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385FB32F-AE22-4D75-A4E0-D74EC503604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298</TotalTime>
  <Words>904</Words>
  <Application>Microsoft Office PowerPoint</Application>
  <PresentationFormat>Letter Paper (8.5x11 in)</PresentationFormat>
  <Paragraphs>290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: Llama immunization strategy; isolation of x-reactive binders</dc:title>
  <dc:creator>Pande, Kalyan</dc:creator>
  <cp:lastModifiedBy>Pande, Kalyan</cp:lastModifiedBy>
  <cp:revision>43</cp:revision>
  <dcterms:created xsi:type="dcterms:W3CDTF">2022-01-11T21:03:25Z</dcterms:created>
  <dcterms:modified xsi:type="dcterms:W3CDTF">2023-07-27T01:44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512FC5133423649B55DE7C5401660E1</vt:lpwstr>
  </property>
  <property fmtid="{D5CDD505-2E9C-101B-9397-08002B2CF9AE}" pid="3" name="MSIP_Label_e81acc0d-dcc4-4dc9-a2c5-be70b05a2fe6_Enabled">
    <vt:lpwstr>true</vt:lpwstr>
  </property>
  <property fmtid="{D5CDD505-2E9C-101B-9397-08002B2CF9AE}" pid="4" name="MSIP_Label_e81acc0d-dcc4-4dc9-a2c5-be70b05a2fe6_SetDate">
    <vt:lpwstr>2023-04-11T03:54:55Z</vt:lpwstr>
  </property>
  <property fmtid="{D5CDD505-2E9C-101B-9397-08002B2CF9AE}" pid="5" name="MSIP_Label_e81acc0d-dcc4-4dc9-a2c5-be70b05a2fe6_Method">
    <vt:lpwstr>Privileged</vt:lpwstr>
  </property>
  <property fmtid="{D5CDD505-2E9C-101B-9397-08002B2CF9AE}" pid="6" name="MSIP_Label_e81acc0d-dcc4-4dc9-a2c5-be70b05a2fe6_Name">
    <vt:lpwstr>e81acc0d-dcc4-4dc9-a2c5-be70b05a2fe6</vt:lpwstr>
  </property>
  <property fmtid="{D5CDD505-2E9C-101B-9397-08002B2CF9AE}" pid="7" name="MSIP_Label_e81acc0d-dcc4-4dc9-a2c5-be70b05a2fe6_SiteId">
    <vt:lpwstr>a00de4ec-48a8-43a6-be74-e31274e2060d</vt:lpwstr>
  </property>
  <property fmtid="{D5CDD505-2E9C-101B-9397-08002B2CF9AE}" pid="8" name="MSIP_Label_e81acc0d-dcc4-4dc9-a2c5-be70b05a2fe6_ActionId">
    <vt:lpwstr>4ccc5b90-e9e0-450b-9866-526765c73bc2</vt:lpwstr>
  </property>
  <property fmtid="{D5CDD505-2E9C-101B-9397-08002B2CF9AE}" pid="9" name="MSIP_Label_e81acc0d-dcc4-4dc9-a2c5-be70b05a2fe6_ContentBits">
    <vt:lpwstr>0</vt:lpwstr>
  </property>
  <property fmtid="{D5CDD505-2E9C-101B-9397-08002B2CF9AE}" pid="10" name="MerckAIPLabel">
    <vt:lpwstr>NotClassified</vt:lpwstr>
  </property>
  <property fmtid="{D5CDD505-2E9C-101B-9397-08002B2CF9AE}" pid="11" name="MerckAIPDataExchange">
    <vt:lpwstr>!MRKMIP@NotClassified</vt:lpwstr>
  </property>
</Properties>
</file>